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7" autoAdjust="0"/>
    <p:restoredTop sz="86199" autoAdjust="0"/>
  </p:normalViewPr>
  <p:slideViewPr>
    <p:cSldViewPr snapToGrid="0">
      <p:cViewPr>
        <p:scale>
          <a:sx n="70" d="100"/>
          <a:sy n="70" d="100"/>
        </p:scale>
        <p:origin x="-508" y="-4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FFFDD5-A5A1-419F-9118-A508A35E82A0}" type="datetimeFigureOut">
              <a:rPr lang="zh-CN" altLang="en-US" smtClean="0"/>
              <a:pPr/>
              <a:t>2020/7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87D693-CCE6-4CAB-A2D0-A28419C5CC6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52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80C4EF-DE02-4060-97D3-A78F3F427602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5598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558406-C2DF-4E1D-9549-7295F63DC6D7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8585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70573" cy="585152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D99719-BCC1-449D-84AF-8E29F019874C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657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1E038C-4898-42D8-8BCB-E29FA6A82D87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2405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366B85-94CE-45C7-8B83-C41FDEFB4E5E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5264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76672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5728" y="1600201"/>
            <a:ext cx="5376672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288233-E2B2-4A0D-AF5B-1B22A0728E02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6905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5" y="1778438"/>
            <a:ext cx="4873575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5" y="2665379"/>
            <a:ext cx="4873575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9" y="1778438"/>
            <a:ext cx="4897576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9" y="2665379"/>
            <a:ext cx="4897576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8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9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530E20-8B2E-4CA0-BBC4-82448DD4108D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424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4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5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AD655A-8E07-438E-8997-57F431947B75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774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3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4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399951-833C-4D32-A8C4-1BBC9BD44219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82770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145590-1029-4DB6-89B3-4F2148B84649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090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7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6" name="页脚占位符 1028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7" name="灯片编号占位符 1029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91B647-EEC0-4698-8C2F-CF5437A03DA6}" type="slidenum">
              <a:rPr lang="zh-CN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481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eaLnBrk="1" hangingPunct="1">
              <a:defRPr sz="1400" noProof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 eaLnBrk="1" hangingPunct="1">
              <a:defRPr sz="1400" noProof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 eaLnBrk="1" hangingPunct="1">
              <a:defRPr sz="1400" noProof="1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5AB0C040-8501-4B88-BA14-A7DC3162022C}" type="slidenum">
              <a:rPr lang="zh-CN" alt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zh-CN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900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3531158" y="1403217"/>
            <a:ext cx="5051536" cy="2203490"/>
            <a:chOff x="1729518" y="2136175"/>
            <a:chExt cx="5051536" cy="2203490"/>
          </a:xfrm>
        </p:grpSpPr>
        <p:pic>
          <p:nvPicPr>
            <p:cNvPr id="4" name="图片 2" descr="新冠图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9518" y="2149263"/>
              <a:ext cx="2371351" cy="21904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图片 1" descr="甲流图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6134" y="2136175"/>
              <a:ext cx="2300963" cy="22034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文本框 31"/>
            <p:cNvSpPr txBox="1">
              <a:spLocks noChangeArrowheads="1"/>
            </p:cNvSpPr>
            <p:nvPr/>
          </p:nvSpPr>
          <p:spPr bwMode="auto">
            <a:xfrm>
              <a:off x="3174444" y="2230740"/>
              <a:ext cx="3606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b="1" dirty="0" smtClean="0">
                  <a:solidFill>
                    <a:srgbClr val="FFFFFF"/>
                  </a:solidFill>
                </a:rPr>
                <a:t>NCP                                                 IAP</a:t>
              </a:r>
              <a:endParaRPr lang="en-US" altLang="zh-CN" sz="1200" b="1" dirty="0">
                <a:solidFill>
                  <a:srgbClr val="FFFFFF"/>
                </a:solidFill>
              </a:endParaRPr>
            </a:p>
          </p:txBody>
        </p:sp>
      </p:grpSp>
      <p:sp>
        <p:nvSpPr>
          <p:cNvPr id="9" name="矩形 8"/>
          <p:cNvSpPr/>
          <p:nvPr/>
        </p:nvSpPr>
        <p:spPr>
          <a:xfrm>
            <a:off x="3174749" y="4189553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dirty="0"/>
              <a:t>Supplementary </a:t>
            </a:r>
            <a:r>
              <a:rPr lang="en-US" altLang="zh-CN" dirty="0" smtClean="0"/>
              <a:t>figure1</a:t>
            </a:r>
            <a:r>
              <a:rPr lang="en-US" altLang="zh-CN" dirty="0"/>
              <a:t> </a:t>
            </a:r>
            <a:r>
              <a:rPr lang="zh-CN" altLang="zh-CN" dirty="0"/>
              <a:t>Computed tomography (CT) images acquisition and region-of-interest (ROI) segmentation of inflammatory lesions in NCP and IAP</a:t>
            </a:r>
          </a:p>
        </p:txBody>
      </p:sp>
    </p:spTree>
    <p:extLst>
      <p:ext uri="{BB962C8B-B14F-4D97-AF65-F5344CB8AC3E}">
        <p14:creationId xmlns:p14="http://schemas.microsoft.com/office/powerpoint/2010/main" val="3717914925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8</TotalTime>
  <Words>4</Words>
  <Application>Microsoft Office PowerPoint</Application>
  <PresentationFormat>自定义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红雷 马</dc:creator>
  <cp:lastModifiedBy>Windows 用户</cp:lastModifiedBy>
  <cp:revision>122</cp:revision>
  <dcterms:created xsi:type="dcterms:W3CDTF">2020-02-11T09:43:06Z</dcterms:created>
  <dcterms:modified xsi:type="dcterms:W3CDTF">2020-07-17T05:54:05Z</dcterms:modified>
</cp:coreProperties>
</file>